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55" r:id="rId2"/>
    <p:sldId id="4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14C117-82CF-7665-2777-BDBDA62C9B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BE7C2D-BF75-28AC-6BBD-85282F1FA7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05FF82-5F65-74BE-7423-4F5CB416D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F1A916-CEFC-35D6-A9F4-56BDC3B62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C7FB4A-5155-780C-889A-18265FBFD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034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FE1A7C-0CC1-1C25-A0D2-2F142FE43A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0C1BC4-3E85-DDCD-2602-DE9BD16070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0972E-D63F-108D-1201-00A2A7646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B8B178-3FAF-4F38-383A-49DFAB9AA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CCDDF8-D33A-1012-E859-8E336C716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5130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82F3E9-C104-9B25-7B56-23E57A13BA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B5350D-FDFD-BDDE-636E-18B9D6C53C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11C9A7-E3C9-30D1-01E3-FC1AD256D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C09EC-CAC4-BBDD-B054-8970AB0B2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5959E-F6E5-D9AD-A4DF-3020FBBFB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720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AB695-102D-B867-FF97-2EA3FFDD66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4967AC-0005-4EC0-1F9F-004BC8FDDC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DCF01-0EB4-3189-8C36-64FA1FDED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DB0746-E977-135F-6A3D-236CB9786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873B3-2814-ECE8-AD7E-20F0E6738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1310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FB753-7FF7-7577-7307-0FA7B9569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405664-A3F6-F325-C86B-41565D2BAD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C0996E-6BBA-92C8-3A81-F88717467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40998B-EAAD-F2AF-E53A-44E68EDD9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F8EC0-9C10-CA5C-00D5-0133CAB73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1976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12AF8-0727-46DA-EF7D-19612B09CB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42395-21E7-9200-F062-5D123B123D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C2286C-CA5B-6422-49ED-0DB1FE6636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7B20F7-CB38-96C2-95DE-5AF5C5801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F56863-2B68-C42B-BF93-ADA36817B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A9850D-7D4D-C6CF-C7B9-2427D3446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373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9D5D2-6E11-818F-EF6C-80187BE08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DAD552-F094-1AC9-9DC5-8AE1007FB1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7BBE63-8472-077D-688E-4A2286E187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47804F-2935-30A5-5CA3-0B235D7ED3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6E02D1-2587-F98E-B8C7-18599968CA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F85201-FE0D-6716-815C-9EE926EB9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2E7072-8587-6B0B-5837-FB4141D20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60324A-F7DB-9FC4-8E40-90662448A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6028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D60E67-F8F2-7B9F-EC63-73454BBFE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C1E79A-7289-3146-D0E2-D1A06119D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A6EF70-32F6-E4E6-5D6F-3DB75D947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453968-6BCD-F332-D557-30A833233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744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E18036-A8A5-5BFA-0755-F2F7616A9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F51622-2CB2-F657-EE62-3A630B44F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170E65-63C9-425D-6BB4-B5BC002A5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9702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9DD8F3-23CE-12D7-B097-9DF488357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039EA1-0396-2C72-0ADB-C91527944E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80CC2F-0A55-28BB-A725-576147C5A8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BDF9FD-D994-93BF-6D23-F42A5C9B4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4EBC41-80F2-4622-45F3-10296E545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C37A30-A213-35D0-1517-F3AFCD24C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425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A8F31-EF4A-D3B2-233E-2CFB71AD6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E9BB7E-F490-3CCB-24EE-079259EAA7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9BA01B-BE09-E584-A592-2098FF668F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258A4F-3CFB-1558-C01E-FD2768956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341318-0B66-7827-1903-77F01ED90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94D932-8122-7ECB-3728-51E5365F1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4137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BD9504-4973-6A7F-9938-EFCB9A8B0B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9DD29F-68B9-B6C9-7791-800EE32F0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C7944C-9B16-49A4-D7A1-28136A1F2F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4483C-7F9F-42D5-A366-F15F0204A0E2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B47E5-7E3A-CAF5-A91D-A09635FAE4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CC1F40-3CA5-3A61-5572-A6E50A121F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BAF42-F1EB-4708-9C25-5602E61A16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2438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>
            <a:extLst>
              <a:ext uri="{FF2B5EF4-FFF2-40B4-BE49-F238E27FC236}">
                <a16:creationId xmlns:a16="http://schemas.microsoft.com/office/drawing/2014/main" id="{1754181C-DD54-4EA5-87B3-445ED342AC90}"/>
              </a:ext>
            </a:extLst>
          </p:cNvPr>
          <p:cNvGrpSpPr/>
          <p:nvPr/>
        </p:nvGrpSpPr>
        <p:grpSpPr>
          <a:xfrm>
            <a:off x="1706756" y="405476"/>
            <a:ext cx="1824097" cy="1433689"/>
            <a:chOff x="185257" y="821527"/>
            <a:chExt cx="1462326" cy="1240929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82330448-D51A-4F43-A9C3-A82508FD52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5257" y="821527"/>
              <a:ext cx="1462326" cy="1054441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A913580-5D2E-4339-BE73-29F8374D08B8}"/>
                </a:ext>
              </a:extLst>
            </p:cNvPr>
            <p:cNvSpPr txBox="1"/>
            <p:nvPr/>
          </p:nvSpPr>
          <p:spPr>
            <a:xfrm>
              <a:off x="497131" y="1811294"/>
              <a:ext cx="1150452" cy="2511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lexinB1</a:t>
              </a:r>
            </a:p>
          </p:txBody>
        </p: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5A5B5BEF-B607-465F-ACCD-B5B357C28AE9}"/>
                </a:ext>
              </a:extLst>
            </p:cNvPr>
            <p:cNvCxnSpPr>
              <a:cxnSpLocks/>
            </p:cNvCxnSpPr>
            <p:nvPr/>
          </p:nvCxnSpPr>
          <p:spPr>
            <a:xfrm>
              <a:off x="263865" y="1811294"/>
              <a:ext cx="13854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5" name="TextBox 114">
            <a:extLst>
              <a:ext uri="{FF2B5EF4-FFF2-40B4-BE49-F238E27FC236}">
                <a16:creationId xmlns:a16="http://schemas.microsoft.com/office/drawing/2014/main" id="{87E26EA2-28FB-4C96-BBCE-2EC314AD9096}"/>
              </a:ext>
            </a:extLst>
          </p:cNvPr>
          <p:cNvSpPr txBox="1"/>
          <p:nvPr/>
        </p:nvSpPr>
        <p:spPr>
          <a:xfrm>
            <a:off x="6262878" y="2806513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S4D647</a:t>
            </a:r>
          </a:p>
        </p:txBody>
      </p: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769A635A-8449-4B02-9885-E8FDF31F9199}"/>
              </a:ext>
            </a:extLst>
          </p:cNvPr>
          <p:cNvGrpSpPr/>
          <p:nvPr/>
        </p:nvGrpSpPr>
        <p:grpSpPr>
          <a:xfrm>
            <a:off x="6770903" y="3090773"/>
            <a:ext cx="3217894" cy="1194200"/>
            <a:chOff x="596585" y="5227041"/>
            <a:chExt cx="3458680" cy="1244404"/>
          </a:xfrm>
        </p:grpSpPr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id="{DEBD6FD6-BFF8-424D-9CEA-DA9226C73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21673" y="5229855"/>
              <a:ext cx="1133592" cy="1046605"/>
            </a:xfrm>
            <a:prstGeom prst="rect">
              <a:avLst/>
            </a:prstGeom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id="{DA8E6AE6-6B30-491B-AC2B-AEF053AD6E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6585" y="5227094"/>
              <a:ext cx="1142016" cy="1054382"/>
            </a:xfrm>
            <a:prstGeom prst="rect">
              <a:avLst/>
            </a:prstGeom>
          </p:spPr>
        </p:pic>
        <p:pic>
          <p:nvPicPr>
            <p:cNvPr id="148" name="Picture 147">
              <a:extLst>
                <a:ext uri="{FF2B5EF4-FFF2-40B4-BE49-F238E27FC236}">
                  <a16:creationId xmlns:a16="http://schemas.microsoft.com/office/drawing/2014/main" id="{25596ACF-F36A-4757-ACDA-089BD2A7E81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64966" y="5227041"/>
              <a:ext cx="1142015" cy="1054382"/>
            </a:xfrm>
            <a:prstGeom prst="rect">
              <a:avLst/>
            </a:prstGeom>
          </p:spPr>
        </p:pic>
        <p:sp>
          <p:nvSpPr>
            <p:cNvPr id="149" name="TextBox 76">
              <a:extLst>
                <a:ext uri="{FF2B5EF4-FFF2-40B4-BE49-F238E27FC236}">
                  <a16:creationId xmlns:a16="http://schemas.microsoft.com/office/drawing/2014/main" id="{3EE63781-DA3A-4440-B992-81466655B81B}"/>
                </a:ext>
              </a:extLst>
            </p:cNvPr>
            <p:cNvSpPr txBox="1"/>
            <p:nvPr/>
          </p:nvSpPr>
          <p:spPr>
            <a:xfrm>
              <a:off x="841596" y="6216398"/>
              <a:ext cx="1236977" cy="24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PlexinB1</a:t>
              </a:r>
            </a:p>
          </p:txBody>
        </p:sp>
        <p:sp>
          <p:nvSpPr>
            <p:cNvPr id="150" name="TextBox 77">
              <a:extLst>
                <a:ext uri="{FF2B5EF4-FFF2-40B4-BE49-F238E27FC236}">
                  <a16:creationId xmlns:a16="http://schemas.microsoft.com/office/drawing/2014/main" id="{9EFA1882-77D7-446B-A32D-944FA820BDAF}"/>
                </a:ext>
              </a:extLst>
            </p:cNvPr>
            <p:cNvSpPr txBox="1"/>
            <p:nvPr/>
          </p:nvSpPr>
          <p:spPr>
            <a:xfrm>
              <a:off x="2027994" y="6216398"/>
              <a:ext cx="1285048" cy="246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/>
                <a:t>RanQ69L</a:t>
              </a:r>
            </a:p>
          </p:txBody>
        </p:sp>
        <p:sp>
          <p:nvSpPr>
            <p:cNvPr id="151" name="TextBox 78">
              <a:extLst>
                <a:ext uri="{FF2B5EF4-FFF2-40B4-BE49-F238E27FC236}">
                  <a16:creationId xmlns:a16="http://schemas.microsoft.com/office/drawing/2014/main" id="{21604AE1-69CB-437F-9EC0-03C22AD67AA2}"/>
                </a:ext>
              </a:extLst>
            </p:cNvPr>
            <p:cNvSpPr txBox="1"/>
            <p:nvPr/>
          </p:nvSpPr>
          <p:spPr>
            <a:xfrm>
              <a:off x="3074559" y="6216398"/>
              <a:ext cx="898677" cy="255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 err="1"/>
                <a:t>merge+Dapi</a:t>
              </a:r>
              <a:endParaRPr lang="en-GB" sz="1200" dirty="0"/>
            </a:p>
          </p:txBody>
        </p: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FA77C716-97CD-4E03-A311-6139DF51E5B3}"/>
                </a:ext>
              </a:extLst>
            </p:cNvPr>
            <p:cNvCxnSpPr/>
            <p:nvPr/>
          </p:nvCxnSpPr>
          <p:spPr>
            <a:xfrm>
              <a:off x="676170" y="6202261"/>
              <a:ext cx="43061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F5572846-3249-4165-8DBC-0D43E17168B2}"/>
              </a:ext>
            </a:extLst>
          </p:cNvPr>
          <p:cNvGrpSpPr/>
          <p:nvPr/>
        </p:nvGrpSpPr>
        <p:grpSpPr>
          <a:xfrm>
            <a:off x="3710099" y="332389"/>
            <a:ext cx="4984954" cy="1553498"/>
            <a:chOff x="7136384" y="765775"/>
            <a:chExt cx="4729910" cy="1348544"/>
          </a:xfrm>
        </p:grpSpPr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E7589CD5-1B02-4EC0-9794-CED20C599A1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295500" y="765775"/>
              <a:ext cx="570794" cy="368728"/>
            </a:xfrm>
            <a:prstGeom prst="rect">
              <a:avLst/>
            </a:prstGeom>
          </p:spPr>
        </p:pic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67530C0B-2582-4B9D-AC91-8D58B804134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3045" y="1203422"/>
              <a:ext cx="62146" cy="107734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id="{36DCD897-C62C-4C6D-878D-50021FB5AE6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909775" y="825264"/>
              <a:ext cx="1357899" cy="1059775"/>
            </a:xfrm>
            <a:prstGeom prst="rect">
              <a:avLst/>
            </a:prstGeom>
          </p:spPr>
        </p:pic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39F374C9-B5A9-4576-A197-80032ABCE01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136384" y="825264"/>
              <a:ext cx="1357899" cy="1059775"/>
            </a:xfrm>
            <a:prstGeom prst="rect">
              <a:avLst/>
            </a:prstGeom>
          </p:spPr>
        </p:pic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E57DA980-DEBB-44AF-BDE9-34AF2F65D77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520627" y="825264"/>
              <a:ext cx="1357899" cy="1059775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DBB3F766-CB82-4450-AAC8-B84B418445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295500" y="1164132"/>
              <a:ext cx="570793" cy="368728"/>
            </a:xfrm>
            <a:prstGeom prst="rect">
              <a:avLst/>
            </a:prstGeom>
          </p:spPr>
        </p:pic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id="{1B01F999-0C46-41AB-97AA-E264D5A82AD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1295500" y="1556805"/>
              <a:ext cx="570794" cy="368728"/>
            </a:xfrm>
            <a:prstGeom prst="rect">
              <a:avLst/>
            </a:prstGeom>
          </p:spPr>
        </p:pic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35F42EE0-0396-4C88-9C7C-FFD1A1B61C80}"/>
                </a:ext>
              </a:extLst>
            </p:cNvPr>
            <p:cNvSpPr txBox="1"/>
            <p:nvPr/>
          </p:nvSpPr>
          <p:spPr>
            <a:xfrm>
              <a:off x="7315083" y="1825470"/>
              <a:ext cx="729144" cy="248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PlexinB1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CC12041-E18F-486B-9836-C07D0194D774}"/>
                </a:ext>
              </a:extLst>
            </p:cNvPr>
            <p:cNvSpPr txBox="1"/>
            <p:nvPr/>
          </p:nvSpPr>
          <p:spPr>
            <a:xfrm>
              <a:off x="8730209" y="1825470"/>
              <a:ext cx="778602" cy="248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RanGAP1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C41A1D90-70AF-4AE9-91B8-669A8F8C7A00}"/>
                </a:ext>
              </a:extLst>
            </p:cNvPr>
            <p:cNvSpPr txBox="1"/>
            <p:nvPr/>
          </p:nvSpPr>
          <p:spPr>
            <a:xfrm>
              <a:off x="10807646" y="1850511"/>
              <a:ext cx="187242" cy="2482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GB" sz="1200" dirty="0"/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66521573-D755-41A9-9150-B7870A7DB4E8}"/>
                </a:ext>
              </a:extLst>
            </p:cNvPr>
            <p:cNvSpPr txBox="1"/>
            <p:nvPr/>
          </p:nvSpPr>
          <p:spPr>
            <a:xfrm>
              <a:off x="10255922" y="1866029"/>
              <a:ext cx="770432" cy="248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1200" dirty="0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C2BAEEDE-5C4B-421A-86AF-FDC15EEBFC1E}"/>
                </a:ext>
              </a:extLst>
            </p:cNvPr>
            <p:cNvSpPr/>
            <p:nvPr/>
          </p:nvSpPr>
          <p:spPr>
            <a:xfrm>
              <a:off x="10211237" y="995295"/>
              <a:ext cx="290051" cy="249626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04EC1118-4C31-4B29-82A4-970191C93506}"/>
                </a:ext>
              </a:extLst>
            </p:cNvPr>
            <p:cNvSpPr txBox="1"/>
            <p:nvPr/>
          </p:nvSpPr>
          <p:spPr>
            <a:xfrm>
              <a:off x="10139190" y="1825470"/>
              <a:ext cx="9442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merge+Dapi</a:t>
              </a:r>
              <a:endParaRPr lang="en-GB" sz="1200" dirty="0"/>
            </a:p>
          </p:txBody>
        </p: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794F2F4E-151E-43AA-A6D0-0B4C03FB8CF3}"/>
                </a:ext>
              </a:extLst>
            </p:cNvPr>
            <p:cNvCxnSpPr>
              <a:cxnSpLocks/>
            </p:cNvCxnSpPr>
            <p:nvPr/>
          </p:nvCxnSpPr>
          <p:spPr>
            <a:xfrm>
              <a:off x="10023275" y="1808865"/>
              <a:ext cx="2729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04CB3416-7345-4277-958C-A4E9C7E92987}"/>
                </a:ext>
              </a:extLst>
            </p:cNvPr>
            <p:cNvCxnSpPr>
              <a:cxnSpLocks/>
            </p:cNvCxnSpPr>
            <p:nvPr/>
          </p:nvCxnSpPr>
          <p:spPr>
            <a:xfrm>
              <a:off x="7203499" y="1808865"/>
              <a:ext cx="2729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F70D7F35-BBC4-4AAE-A4F1-0C4493DCBD6C}"/>
                </a:ext>
              </a:extLst>
            </p:cNvPr>
            <p:cNvCxnSpPr>
              <a:cxnSpLocks/>
            </p:cNvCxnSpPr>
            <p:nvPr/>
          </p:nvCxnSpPr>
          <p:spPr>
            <a:xfrm>
              <a:off x="8610316" y="1808865"/>
              <a:ext cx="2729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8CE8D0C3-3625-417D-91AD-0C3D21F24E19}"/>
              </a:ext>
            </a:extLst>
          </p:cNvPr>
          <p:cNvGrpSpPr/>
          <p:nvPr/>
        </p:nvGrpSpPr>
        <p:grpSpPr>
          <a:xfrm>
            <a:off x="1703522" y="4277712"/>
            <a:ext cx="5963144" cy="2344756"/>
            <a:chOff x="217622" y="3726776"/>
            <a:chExt cx="5963144" cy="234475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7BDBB23-B6E3-4E2E-AA3B-78DF3441AB8D}"/>
                </a:ext>
              </a:extLst>
            </p:cNvPr>
            <p:cNvGrpSpPr/>
            <p:nvPr/>
          </p:nvGrpSpPr>
          <p:grpSpPr>
            <a:xfrm>
              <a:off x="217622" y="3726776"/>
              <a:ext cx="5963144" cy="2344756"/>
              <a:chOff x="1324602" y="2470518"/>
              <a:chExt cx="5690363" cy="1968404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9B7E66C2-14EB-4714-AF4A-118A2C1FDC5C}"/>
                  </a:ext>
                </a:extLst>
              </p:cNvPr>
              <p:cNvGrpSpPr/>
              <p:nvPr/>
            </p:nvGrpSpPr>
            <p:grpSpPr>
              <a:xfrm>
                <a:off x="1324602" y="3121056"/>
                <a:ext cx="4974923" cy="1165989"/>
                <a:chOff x="-1351481" y="1924049"/>
                <a:chExt cx="6347171" cy="1684376"/>
              </a:xfrm>
            </p:grpSpPr>
            <p:pic>
              <p:nvPicPr>
                <p:cNvPr id="38" name="Picture 37">
                  <a:extLst>
                    <a:ext uri="{FF2B5EF4-FFF2-40B4-BE49-F238E27FC236}">
                      <a16:creationId xmlns:a16="http://schemas.microsoft.com/office/drawing/2014/main" id="{8ED07D02-B9A7-43AD-AF6C-730E6FBE14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3457782" y="1924050"/>
                  <a:ext cx="1537908" cy="1684375"/>
                </a:xfrm>
                <a:prstGeom prst="rect">
                  <a:avLst/>
                </a:prstGeom>
              </p:spPr>
            </p:pic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B186B325-A09C-4692-B092-6BC81DB5BD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1848139" y="1924049"/>
                  <a:ext cx="1537908" cy="1684375"/>
                </a:xfrm>
                <a:prstGeom prst="rect">
                  <a:avLst/>
                </a:prstGeom>
              </p:spPr>
            </p:pic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CFBD7C9C-5118-4CD3-88AD-74753D4DBB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-1351481" y="1924049"/>
                  <a:ext cx="1537908" cy="1684375"/>
                </a:xfrm>
                <a:prstGeom prst="rect">
                  <a:avLst/>
                </a:prstGeom>
              </p:spPr>
            </p:pic>
            <p:pic>
              <p:nvPicPr>
                <p:cNvPr id="41" name="Picture 40">
                  <a:extLst>
                    <a:ext uri="{FF2B5EF4-FFF2-40B4-BE49-F238E27FC236}">
                      <a16:creationId xmlns:a16="http://schemas.microsoft.com/office/drawing/2014/main" id="{E1F10C7B-7DFE-46B1-B5B5-C9AD5939656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248329" y="1924049"/>
                  <a:ext cx="1537908" cy="1684375"/>
                </a:xfrm>
                <a:prstGeom prst="rect">
                  <a:avLst/>
                </a:prstGeom>
              </p:spPr>
            </p:pic>
          </p:grp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839F655-41E5-4385-BAF9-723948848B9F}"/>
                  </a:ext>
                </a:extLst>
              </p:cNvPr>
              <p:cNvSpPr txBox="1"/>
              <p:nvPr/>
            </p:nvSpPr>
            <p:spPr>
              <a:xfrm>
                <a:off x="1510400" y="4247173"/>
                <a:ext cx="773111" cy="191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ytoPlexinB1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FB3A1BA-0639-4B4D-B46A-80B780A31D13}"/>
                  </a:ext>
                </a:extLst>
              </p:cNvPr>
              <p:cNvSpPr txBox="1"/>
              <p:nvPr/>
            </p:nvSpPr>
            <p:spPr>
              <a:xfrm>
                <a:off x="2843253" y="4247173"/>
                <a:ext cx="585751" cy="191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RanQ69L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DB6B164-3CB6-4274-A72E-E7790824D559}"/>
                  </a:ext>
                </a:extLst>
              </p:cNvPr>
              <p:cNvSpPr txBox="1"/>
              <p:nvPr/>
            </p:nvSpPr>
            <p:spPr>
              <a:xfrm>
                <a:off x="5383459" y="4247173"/>
                <a:ext cx="457443" cy="191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merge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90914B5-6CA0-479F-AE0E-ECA525B1BDE9}"/>
                  </a:ext>
                </a:extLst>
              </p:cNvPr>
              <p:cNvSpPr txBox="1"/>
              <p:nvPr/>
            </p:nvSpPr>
            <p:spPr>
              <a:xfrm>
                <a:off x="4261343" y="4247173"/>
                <a:ext cx="367131" cy="191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/>
                  <a:t>Dapi</a:t>
                </a:r>
                <a:endParaRPr lang="en-GB" sz="1200" dirty="0"/>
              </a:p>
            </p:txBody>
          </p: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D3CAEB8C-2B47-4829-9F38-2E9C0E74934B}"/>
                  </a:ext>
                </a:extLst>
              </p:cNvPr>
              <p:cNvGrpSpPr/>
              <p:nvPr/>
            </p:nvGrpSpPr>
            <p:grpSpPr>
              <a:xfrm>
                <a:off x="3833440" y="2470518"/>
                <a:ext cx="2470962" cy="616478"/>
                <a:chOff x="2977339" y="436532"/>
                <a:chExt cx="3811935" cy="1075936"/>
              </a:xfrm>
            </p:grpSpPr>
            <p:pic>
              <p:nvPicPr>
                <p:cNvPr id="32" name="Picture 31">
                  <a:extLst>
                    <a:ext uri="{FF2B5EF4-FFF2-40B4-BE49-F238E27FC236}">
                      <a16:creationId xmlns:a16="http://schemas.microsoft.com/office/drawing/2014/main" id="{2F56515A-2DD9-4F27-95F1-C141A8F2A4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2977339" y="436532"/>
                  <a:ext cx="1249741" cy="1075936"/>
                </a:xfrm>
                <a:prstGeom prst="rect">
                  <a:avLst/>
                </a:prstGeom>
              </p:spPr>
            </p:pic>
            <p:pic>
              <p:nvPicPr>
                <p:cNvPr id="33" name="Picture 32">
                  <a:extLst>
                    <a:ext uri="{FF2B5EF4-FFF2-40B4-BE49-F238E27FC236}">
                      <a16:creationId xmlns:a16="http://schemas.microsoft.com/office/drawing/2014/main" id="{E50A3B6C-D7FF-4F46-B20D-A192D72993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4265076" y="436532"/>
                  <a:ext cx="1249741" cy="1075936"/>
                </a:xfrm>
                <a:prstGeom prst="rect">
                  <a:avLst/>
                </a:prstGeom>
              </p:spPr>
            </p:pic>
            <p:pic>
              <p:nvPicPr>
                <p:cNvPr id="34" name="Picture 33">
                  <a:extLst>
                    <a:ext uri="{FF2B5EF4-FFF2-40B4-BE49-F238E27FC236}">
                      <a16:creationId xmlns:a16="http://schemas.microsoft.com/office/drawing/2014/main" id="{F805DC05-C96F-4324-B7E1-D55AD8A339B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5539533" y="436532"/>
                  <a:ext cx="1249741" cy="1075936"/>
                </a:xfrm>
                <a:prstGeom prst="rect">
                  <a:avLst/>
                </a:prstGeom>
              </p:spPr>
            </p:pic>
            <p:cxnSp>
              <p:nvCxnSpPr>
                <p:cNvPr id="35" name="Straight Arrow Connector 34">
                  <a:extLst>
                    <a:ext uri="{FF2B5EF4-FFF2-40B4-BE49-F238E27FC236}">
                      <a16:creationId xmlns:a16="http://schemas.microsoft.com/office/drawing/2014/main" id="{2D263A1A-D477-4463-99AA-90CFC62A2BE0}"/>
                    </a:ext>
                  </a:extLst>
                </p:cNvPr>
                <p:cNvCxnSpPr/>
                <p:nvPr/>
              </p:nvCxnSpPr>
              <p:spPr>
                <a:xfrm>
                  <a:off x="5801710" y="949443"/>
                  <a:ext cx="0" cy="184666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headEnd type="none" w="med" len="med"/>
                  <a:tailEnd type="arrow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Arrow Connector 35">
                  <a:extLst>
                    <a:ext uri="{FF2B5EF4-FFF2-40B4-BE49-F238E27FC236}">
                      <a16:creationId xmlns:a16="http://schemas.microsoft.com/office/drawing/2014/main" id="{4BBB4FDE-774A-44A4-B1CD-1804E0DDF73D}"/>
                    </a:ext>
                  </a:extLst>
                </p:cNvPr>
                <p:cNvCxnSpPr/>
                <p:nvPr/>
              </p:nvCxnSpPr>
              <p:spPr>
                <a:xfrm>
                  <a:off x="4459113" y="974500"/>
                  <a:ext cx="0" cy="184666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headEnd type="none" w="med" len="med"/>
                  <a:tailEnd type="arrow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Arrow Connector 36">
                  <a:extLst>
                    <a:ext uri="{FF2B5EF4-FFF2-40B4-BE49-F238E27FC236}">
                      <a16:creationId xmlns:a16="http://schemas.microsoft.com/office/drawing/2014/main" id="{5C2F2A14-B453-4BAE-8F00-4BD82FC29438}"/>
                    </a:ext>
                  </a:extLst>
                </p:cNvPr>
                <p:cNvCxnSpPr/>
                <p:nvPr/>
              </p:nvCxnSpPr>
              <p:spPr>
                <a:xfrm>
                  <a:off x="3206386" y="974500"/>
                  <a:ext cx="0" cy="184666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headEnd type="none" w="med" len="med"/>
                  <a:tailEnd type="arrow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57EDCE0A-A93B-4B9B-ADC9-002097632126}"/>
                  </a:ext>
                </a:extLst>
              </p:cNvPr>
              <p:cNvGrpSpPr/>
              <p:nvPr/>
            </p:nvGrpSpPr>
            <p:grpSpPr>
              <a:xfrm>
                <a:off x="6343051" y="3178334"/>
                <a:ext cx="671914" cy="348176"/>
                <a:chOff x="6971060" y="1168936"/>
                <a:chExt cx="857250" cy="502972"/>
              </a:xfrm>
            </p:grpSpPr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94F06D44-AD41-436E-B12D-FDCCCA4838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6971060" y="1168936"/>
                  <a:ext cx="857250" cy="457200"/>
                </a:xfrm>
                <a:prstGeom prst="rect">
                  <a:avLst/>
                </a:prstGeom>
              </p:spPr>
            </p:pic>
            <p:cxnSp>
              <p:nvCxnSpPr>
                <p:cNvPr id="31" name="Straight Arrow Connector 30">
                  <a:extLst>
                    <a:ext uri="{FF2B5EF4-FFF2-40B4-BE49-F238E27FC236}">
                      <a16:creationId xmlns:a16="http://schemas.microsoft.com/office/drawing/2014/main" id="{1F56F4E8-487D-443D-8023-B0C1869207FB}"/>
                    </a:ext>
                  </a:extLst>
                </p:cNvPr>
                <p:cNvCxnSpPr/>
                <p:nvPr/>
              </p:nvCxnSpPr>
              <p:spPr>
                <a:xfrm flipV="1">
                  <a:off x="7424745" y="1560813"/>
                  <a:ext cx="119641" cy="111095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7EBF658F-DF07-45A8-B65C-627D7126A4E6}"/>
                  </a:ext>
                </a:extLst>
              </p:cNvPr>
              <p:cNvGrpSpPr/>
              <p:nvPr/>
            </p:nvGrpSpPr>
            <p:grpSpPr>
              <a:xfrm>
                <a:off x="6343051" y="3523553"/>
                <a:ext cx="671914" cy="338310"/>
                <a:chOff x="7917261" y="1164868"/>
                <a:chExt cx="857250" cy="488719"/>
              </a:xfrm>
            </p:grpSpPr>
            <p:pic>
              <p:nvPicPr>
                <p:cNvPr id="28" name="Picture 27">
                  <a:extLst>
                    <a:ext uri="{FF2B5EF4-FFF2-40B4-BE49-F238E27FC236}">
                      <a16:creationId xmlns:a16="http://schemas.microsoft.com/office/drawing/2014/main" id="{ACA94E0C-A5D2-4E35-AE39-85D1DB45AC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/>
                <a:stretch>
                  <a:fillRect/>
                </a:stretch>
              </p:blipFill>
              <p:spPr>
                <a:xfrm>
                  <a:off x="7917261" y="1164868"/>
                  <a:ext cx="857250" cy="457200"/>
                </a:xfrm>
                <a:prstGeom prst="rect">
                  <a:avLst/>
                </a:prstGeom>
              </p:spPr>
            </p:pic>
            <p:cxnSp>
              <p:nvCxnSpPr>
                <p:cNvPr id="29" name="Straight Arrow Connector 28">
                  <a:extLst>
                    <a:ext uri="{FF2B5EF4-FFF2-40B4-BE49-F238E27FC236}">
                      <a16:creationId xmlns:a16="http://schemas.microsoft.com/office/drawing/2014/main" id="{EEAC7F0B-C1B0-46A8-8F42-94F7CC6455A3}"/>
                    </a:ext>
                  </a:extLst>
                </p:cNvPr>
                <p:cNvCxnSpPr/>
                <p:nvPr/>
              </p:nvCxnSpPr>
              <p:spPr>
                <a:xfrm flipV="1">
                  <a:off x="8344461" y="1542492"/>
                  <a:ext cx="119641" cy="111095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DF2680F2-8319-4BEA-AC67-B0D059F54E4F}"/>
                  </a:ext>
                </a:extLst>
              </p:cNvPr>
              <p:cNvGrpSpPr/>
              <p:nvPr/>
            </p:nvGrpSpPr>
            <p:grpSpPr>
              <a:xfrm>
                <a:off x="6341934" y="3868529"/>
                <a:ext cx="671914" cy="336406"/>
                <a:chOff x="8796656" y="1167619"/>
                <a:chExt cx="857250" cy="485969"/>
              </a:xfrm>
            </p:grpSpPr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F4CB0D6D-30E8-4105-BC25-1CF2AA055F4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8796656" y="1167619"/>
                  <a:ext cx="857250" cy="457200"/>
                </a:xfrm>
                <a:prstGeom prst="rect">
                  <a:avLst/>
                </a:prstGeom>
              </p:spPr>
            </p:pic>
            <p:cxnSp>
              <p:nvCxnSpPr>
                <p:cNvPr id="27" name="Straight Arrow Connector 26">
                  <a:extLst>
                    <a:ext uri="{FF2B5EF4-FFF2-40B4-BE49-F238E27FC236}">
                      <a16:creationId xmlns:a16="http://schemas.microsoft.com/office/drawing/2014/main" id="{016DE446-6F05-4FFF-BBB8-C1ED6332427E}"/>
                    </a:ext>
                  </a:extLst>
                </p:cNvPr>
                <p:cNvCxnSpPr/>
                <p:nvPr/>
              </p:nvCxnSpPr>
              <p:spPr>
                <a:xfrm flipV="1">
                  <a:off x="9225281" y="1542493"/>
                  <a:ext cx="119641" cy="111095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BB91956E-2B42-4192-9F0C-61994A86C670}"/>
                  </a:ext>
                </a:extLst>
              </p:cNvPr>
              <p:cNvSpPr/>
              <p:nvPr/>
            </p:nvSpPr>
            <p:spPr>
              <a:xfrm>
                <a:off x="5244077" y="3279926"/>
                <a:ext cx="278763" cy="24979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807476A3-E7DB-4E74-ADE7-D3B5D64611FD}"/>
                  </a:ext>
                </a:extLst>
              </p:cNvPr>
              <p:cNvSpPr/>
              <p:nvPr/>
            </p:nvSpPr>
            <p:spPr>
              <a:xfrm>
                <a:off x="5454274" y="4030564"/>
                <a:ext cx="278763" cy="142574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2F412C92-D494-4699-9988-FAE1E2234D86}"/>
                </a:ext>
              </a:extLst>
            </p:cNvPr>
            <p:cNvCxnSpPr/>
            <p:nvPr/>
          </p:nvCxnSpPr>
          <p:spPr>
            <a:xfrm>
              <a:off x="4375276" y="5800094"/>
              <a:ext cx="385979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535F310D-6348-4D7B-83DE-F8E9C5C06D56}"/>
              </a:ext>
            </a:extLst>
          </p:cNvPr>
          <p:cNvSpPr txBox="1"/>
          <p:nvPr/>
        </p:nvSpPr>
        <p:spPr>
          <a:xfrm>
            <a:off x="1417894" y="23699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35115E-771D-4351-A6C4-A658032B6CA5}"/>
              </a:ext>
            </a:extLst>
          </p:cNvPr>
          <p:cNvSpPr txBox="1"/>
          <p:nvPr/>
        </p:nvSpPr>
        <p:spPr>
          <a:xfrm>
            <a:off x="3498383" y="236996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B</a:t>
            </a: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E2AB65A9-B90A-8263-FD16-F1F9501DE6FC}"/>
              </a:ext>
            </a:extLst>
          </p:cNvPr>
          <p:cNvGrpSpPr/>
          <p:nvPr/>
        </p:nvGrpSpPr>
        <p:grpSpPr>
          <a:xfrm>
            <a:off x="1703522" y="1879737"/>
            <a:ext cx="8277569" cy="1088215"/>
            <a:chOff x="1703522" y="1879737"/>
            <a:chExt cx="8277569" cy="1088215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21C5143-D48E-4CAA-9CC7-59F0DB76B0FE}"/>
                </a:ext>
              </a:extLst>
            </p:cNvPr>
            <p:cNvSpPr txBox="1"/>
            <p:nvPr/>
          </p:nvSpPr>
          <p:spPr>
            <a:xfrm>
              <a:off x="6620488" y="2233240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E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55F27CF-6E4C-4D4C-B2B4-9E7C501B0A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703522" y="1879737"/>
              <a:ext cx="8277569" cy="1088215"/>
            </a:xfrm>
            <a:prstGeom prst="rect">
              <a:avLst/>
            </a:prstGeom>
          </p:spPr>
        </p:pic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E594EF79-4627-4E1A-8317-77C8C0190233}"/>
                </a:ext>
              </a:extLst>
            </p:cNvPr>
            <p:cNvCxnSpPr/>
            <p:nvPr/>
          </p:nvCxnSpPr>
          <p:spPr>
            <a:xfrm flipH="1" flipV="1">
              <a:off x="9358988" y="2263292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Arrow Connector 152">
              <a:extLst>
                <a:ext uri="{FF2B5EF4-FFF2-40B4-BE49-F238E27FC236}">
                  <a16:creationId xmlns:a16="http://schemas.microsoft.com/office/drawing/2014/main" id="{E46BED1F-6798-4D7F-A519-DB8005BA1E14}"/>
                </a:ext>
              </a:extLst>
            </p:cNvPr>
            <p:cNvCxnSpPr/>
            <p:nvPr/>
          </p:nvCxnSpPr>
          <p:spPr>
            <a:xfrm flipH="1" flipV="1">
              <a:off x="5934599" y="2182605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Arrow Connector 157">
              <a:extLst>
                <a:ext uri="{FF2B5EF4-FFF2-40B4-BE49-F238E27FC236}">
                  <a16:creationId xmlns:a16="http://schemas.microsoft.com/office/drawing/2014/main" id="{82928B5E-5D92-4332-8EF9-6EB530B7FA15}"/>
                </a:ext>
              </a:extLst>
            </p:cNvPr>
            <p:cNvCxnSpPr/>
            <p:nvPr/>
          </p:nvCxnSpPr>
          <p:spPr>
            <a:xfrm flipH="1" flipV="1">
              <a:off x="7057710" y="2276944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Arrow Connector 158">
              <a:extLst>
                <a:ext uri="{FF2B5EF4-FFF2-40B4-BE49-F238E27FC236}">
                  <a16:creationId xmlns:a16="http://schemas.microsoft.com/office/drawing/2014/main" id="{793439DC-DD57-44B1-B7E2-CA169C6D0959}"/>
                </a:ext>
              </a:extLst>
            </p:cNvPr>
            <p:cNvCxnSpPr/>
            <p:nvPr/>
          </p:nvCxnSpPr>
          <p:spPr>
            <a:xfrm flipH="1" flipV="1">
              <a:off x="8250266" y="2263498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Arrow Connector 159">
              <a:extLst>
                <a:ext uri="{FF2B5EF4-FFF2-40B4-BE49-F238E27FC236}">
                  <a16:creationId xmlns:a16="http://schemas.microsoft.com/office/drawing/2014/main" id="{19731A1A-408C-4DF9-B9B4-76A137380B4F}"/>
                </a:ext>
              </a:extLst>
            </p:cNvPr>
            <p:cNvCxnSpPr/>
            <p:nvPr/>
          </p:nvCxnSpPr>
          <p:spPr>
            <a:xfrm flipH="1" flipV="1">
              <a:off x="3664151" y="2047510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Arrow Connector 160">
              <a:extLst>
                <a:ext uri="{FF2B5EF4-FFF2-40B4-BE49-F238E27FC236}">
                  <a16:creationId xmlns:a16="http://schemas.microsoft.com/office/drawing/2014/main" id="{844D9079-A1C9-49DC-8801-13EA07A40763}"/>
                </a:ext>
              </a:extLst>
            </p:cNvPr>
            <p:cNvCxnSpPr/>
            <p:nvPr/>
          </p:nvCxnSpPr>
          <p:spPr>
            <a:xfrm flipH="1" flipV="1">
              <a:off x="4795238" y="2094632"/>
              <a:ext cx="78093" cy="97971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EE427852-4C62-4BF6-933B-F8DAF193D274}"/>
              </a:ext>
            </a:extLst>
          </p:cNvPr>
          <p:cNvSpPr txBox="1"/>
          <p:nvPr/>
        </p:nvSpPr>
        <p:spPr>
          <a:xfrm>
            <a:off x="1428510" y="178656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7733BDF-4798-46DB-85D2-32E85E325AA8}"/>
              </a:ext>
            </a:extLst>
          </p:cNvPr>
          <p:cNvSpPr txBox="1"/>
          <p:nvPr/>
        </p:nvSpPr>
        <p:spPr>
          <a:xfrm>
            <a:off x="1400719" y="5001584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FC8CBD2-86A2-4655-976F-91A9B1B629CA}"/>
              </a:ext>
            </a:extLst>
          </p:cNvPr>
          <p:cNvSpPr txBox="1"/>
          <p:nvPr/>
        </p:nvSpPr>
        <p:spPr>
          <a:xfrm>
            <a:off x="6448040" y="3039314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F</a:t>
            </a: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2F7E49B1-28C3-D63B-A5D3-AFC1509C326B}"/>
              </a:ext>
            </a:extLst>
          </p:cNvPr>
          <p:cNvGrpSpPr/>
          <p:nvPr/>
        </p:nvGrpSpPr>
        <p:grpSpPr>
          <a:xfrm>
            <a:off x="1454320" y="2864867"/>
            <a:ext cx="3991639" cy="1337808"/>
            <a:chOff x="1454320" y="2864867"/>
            <a:chExt cx="3991639" cy="1337808"/>
          </a:xfrm>
        </p:grpSpPr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D582C4E6-DFEA-4C5E-9C0F-CEAA2CB5C4D4}"/>
                </a:ext>
              </a:extLst>
            </p:cNvPr>
            <p:cNvSpPr txBox="1"/>
            <p:nvPr/>
          </p:nvSpPr>
          <p:spPr>
            <a:xfrm>
              <a:off x="4458393" y="3886137"/>
              <a:ext cx="987566" cy="316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merge+Dapi</a:t>
              </a:r>
              <a:endParaRPr lang="en-GB" sz="1200" dirty="0"/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593EB83F-65A9-4591-A9CF-9DB92CEE2C61}"/>
                </a:ext>
              </a:extLst>
            </p:cNvPr>
            <p:cNvSpPr txBox="1"/>
            <p:nvPr/>
          </p:nvSpPr>
          <p:spPr>
            <a:xfrm>
              <a:off x="1454320" y="2979194"/>
              <a:ext cx="2952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D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44880351-6D31-4919-B861-11A3D160BF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4378532" y="3036358"/>
              <a:ext cx="841386" cy="901098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18029979-E2A4-4464-8A8D-AE61A7A998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700717" y="3036358"/>
              <a:ext cx="857738" cy="91861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8F51477F-847E-48DA-80E0-0FE49CBCD7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3469692" y="3038742"/>
              <a:ext cx="857738" cy="918609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C6A9791B-4439-4118-A3EE-172D13B3CB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589772" y="3036358"/>
              <a:ext cx="853311" cy="913869"/>
            </a:xfrm>
            <a:prstGeom prst="rect">
              <a:avLst/>
            </a:prstGeom>
          </p:spPr>
        </p:pic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F83C7BAE-D958-45E9-8757-68AB59C6AED8}"/>
                </a:ext>
              </a:extLst>
            </p:cNvPr>
            <p:cNvCxnSpPr/>
            <p:nvPr/>
          </p:nvCxnSpPr>
          <p:spPr>
            <a:xfrm>
              <a:off x="1734744" y="2864867"/>
              <a:ext cx="40719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7376580-5956-2DA4-DF82-52A28AB24971}"/>
                </a:ext>
              </a:extLst>
            </p:cNvPr>
            <p:cNvSpPr txBox="1"/>
            <p:nvPr/>
          </p:nvSpPr>
          <p:spPr>
            <a:xfrm>
              <a:off x="2582985" y="3886137"/>
              <a:ext cx="9365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Tubulin-GFP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0FF1CF68-EC8A-F203-DC3A-73877145C16A}"/>
                </a:ext>
              </a:extLst>
            </p:cNvPr>
            <p:cNvSpPr txBox="1"/>
            <p:nvPr/>
          </p:nvSpPr>
          <p:spPr>
            <a:xfrm>
              <a:off x="1515729" y="3886137"/>
              <a:ext cx="11651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ema4D-Fc-647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1F0CF64-2119-1D4A-4101-54E243F98A6B}"/>
                </a:ext>
              </a:extLst>
            </p:cNvPr>
            <p:cNvSpPr txBox="1"/>
            <p:nvPr/>
          </p:nvSpPr>
          <p:spPr>
            <a:xfrm>
              <a:off x="3694286" y="3886137"/>
              <a:ext cx="384730" cy="2284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Dapi</a:t>
              </a:r>
              <a:endParaRPr lang="en-GB" sz="1200" dirty="0"/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7C0889F0-1CFE-9152-8765-8B133A7714BF}"/>
              </a:ext>
            </a:extLst>
          </p:cNvPr>
          <p:cNvSpPr txBox="1"/>
          <p:nvPr/>
        </p:nvSpPr>
        <p:spPr>
          <a:xfrm>
            <a:off x="2620541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30’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AF58A78-603B-B22F-0ED9-11919BCA6A4E}"/>
              </a:ext>
            </a:extLst>
          </p:cNvPr>
          <p:cNvSpPr txBox="1"/>
          <p:nvPr/>
        </p:nvSpPr>
        <p:spPr>
          <a:xfrm>
            <a:off x="3783789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32’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4A29A13-DAB5-55A5-DCD9-58C31CDDD0C4}"/>
              </a:ext>
            </a:extLst>
          </p:cNvPr>
          <p:cNvSpPr txBox="1"/>
          <p:nvPr/>
        </p:nvSpPr>
        <p:spPr>
          <a:xfrm>
            <a:off x="4976154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34’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B448634-37D2-426A-5358-33C362795362}"/>
              </a:ext>
            </a:extLst>
          </p:cNvPr>
          <p:cNvSpPr txBox="1"/>
          <p:nvPr/>
        </p:nvSpPr>
        <p:spPr>
          <a:xfrm>
            <a:off x="6168519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36’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F3C9049-2C01-D3F9-8527-C080D504EE9E}"/>
              </a:ext>
            </a:extLst>
          </p:cNvPr>
          <p:cNvSpPr txBox="1"/>
          <p:nvPr/>
        </p:nvSpPr>
        <p:spPr>
          <a:xfrm>
            <a:off x="7330383" y="280265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38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287DA0A-9940-811A-A631-C03CCCC17C68}"/>
              </a:ext>
            </a:extLst>
          </p:cNvPr>
          <p:cNvSpPr txBox="1"/>
          <p:nvPr/>
        </p:nvSpPr>
        <p:spPr>
          <a:xfrm>
            <a:off x="8523864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40’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697E86D-E9CF-6378-0474-511BA32E5B7B}"/>
              </a:ext>
            </a:extLst>
          </p:cNvPr>
          <p:cNvSpPr txBox="1"/>
          <p:nvPr/>
        </p:nvSpPr>
        <p:spPr>
          <a:xfrm>
            <a:off x="9721084" y="28026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>
                    <a:lumMod val="75000"/>
                  </a:schemeClr>
                </a:solidFill>
              </a:rPr>
              <a:t>42’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36D8721-A77A-9201-D4F3-209790045AE6}"/>
              </a:ext>
            </a:extLst>
          </p:cNvPr>
          <p:cNvSpPr txBox="1"/>
          <p:nvPr/>
        </p:nvSpPr>
        <p:spPr>
          <a:xfrm>
            <a:off x="9950776" y="1977950"/>
            <a:ext cx="9365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00B050"/>
                </a:solidFill>
              </a:rPr>
              <a:t>GFP-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790A9D-61D4-9D54-5D5A-F610EFDE27B3}"/>
              </a:ext>
            </a:extLst>
          </p:cNvPr>
          <p:cNvSpPr txBox="1"/>
          <p:nvPr/>
        </p:nvSpPr>
        <p:spPr>
          <a:xfrm>
            <a:off x="9950776" y="2250919"/>
            <a:ext cx="1969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Ch-Histo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28CDBB-63C0-432F-C423-8DBC5A2F6FB5}"/>
              </a:ext>
            </a:extLst>
          </p:cNvPr>
          <p:cNvSpPr txBox="1"/>
          <p:nvPr/>
        </p:nvSpPr>
        <p:spPr>
          <a:xfrm>
            <a:off x="9950776" y="2568668"/>
            <a:ext cx="938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CC00CC"/>
                </a:solidFill>
              </a:rPr>
              <a:t>Sema4D647</a:t>
            </a:r>
          </a:p>
        </p:txBody>
      </p:sp>
    </p:spTree>
    <p:extLst>
      <p:ext uri="{BB962C8B-B14F-4D97-AF65-F5344CB8AC3E}">
        <p14:creationId xmlns:p14="http://schemas.microsoft.com/office/powerpoint/2010/main" val="622388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9602FEE-86F8-0783-F7A2-6053B4B53A50}"/>
              </a:ext>
            </a:extLst>
          </p:cNvPr>
          <p:cNvSpPr txBox="1"/>
          <p:nvPr/>
        </p:nvSpPr>
        <p:spPr>
          <a:xfrm>
            <a:off x="1399256" y="1208283"/>
            <a:ext cx="8982512" cy="34651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10.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bcellular localisation of PlexinB1, Sema4D and Ran 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ssociated with figure 7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,B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PlexinB1 is expressed at the cell membrane and in the cytoplasm. 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NCaP cells stained for endogenous PlexinB1, arrow shows membrane staining (x40 magnification scale bar=10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 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OS7 cells transfected with PlexinB1(FL)-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c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fixed and labelled with anti-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c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green) and anti-RanGAP1 (red) antibodies. Arrow in zoomed images shows overlap of PlexinB1 and RanGAP1 staining around the nuclear envelope, (x60 magnification, scale bar=10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 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-E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Uptake of exogenous Sema4D-Fc-647 into the cell.  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tills from time lapse video of HeLa cells expressing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FP-tubulin(green) and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Histone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red) treated with Sema4D-Fc-647 (cyan) 30 mins after addition of Sema4D-Fc-647, imaged every 2 mins. Arrow denotes Sema4D-Fc-647 within cell (x60 magnification, scale bar=25 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HeLa cell expressing tubulin-GFP, treated with Sema4D-Fc-647 for 2 hrs and stained with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api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(x60 magnification, scale bar=20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 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onfocal image of COS7 cells co-transfected with cytoPlexinB1-myc (green) and RanQ69L-cherry (red); arrow in zoomed image shows co-localisation of PlexinB1 and RanQ69L at cell membrane; (Pearson’s coefficient 0.846), scale bar 20 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HeLa cell co-transfected with PlexinB1(full length)-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c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RanQ69-cherry, stained for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yc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green) and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api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Pearson's Coefficient: r=0.879) (x60 magnification, scale bar=20</a:t>
            </a:r>
            <a:r>
              <a:rPr lang="en-GB" sz="1200" kern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 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4ADE6B-4D28-01D6-6378-4479CD1CCC8E}"/>
              </a:ext>
            </a:extLst>
          </p:cNvPr>
          <p:cNvSpPr txBox="1"/>
          <p:nvPr/>
        </p:nvSpPr>
        <p:spPr>
          <a:xfrm>
            <a:off x="1399256" y="5024577"/>
            <a:ext cx="9090783" cy="12502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video. </a:t>
            </a: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a cells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expressing GFP-tubulin and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Cherry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histone treated with Sema4D-Fc-Alexa647 (white), 2 min time frames, total time of 25 min, x60 magnification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4361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5</Words>
  <Application>Microsoft Office PowerPoint</Application>
  <PresentationFormat>Widescreen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7:11Z</dcterms:created>
  <dcterms:modified xsi:type="dcterms:W3CDTF">2023-06-02T16:48:28Z</dcterms:modified>
</cp:coreProperties>
</file>